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7" r:id="rId2"/>
    <p:sldId id="258" r:id="rId3"/>
  </p:sldIdLst>
  <p:sldSz cx="9144000" cy="6858000" type="screen4x3"/>
  <p:notesSz cx="6742113" cy="987266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74"/>
  </p:normalViewPr>
  <p:slideViewPr>
    <p:cSldViewPr>
      <p:cViewPr>
        <p:scale>
          <a:sx n="118" d="100"/>
          <a:sy n="118" d="100"/>
        </p:scale>
        <p:origin x="-516" y="112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1.xlsx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lang="ja-JP" sz="1600"/>
            </a:pPr>
            <a:r>
              <a:rPr lang="en-US" sz="1600"/>
              <a:t>BT-2mM PCA</a:t>
            </a:r>
            <a:endParaRPr lang="ja-JP" sz="1600"/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22652932534376599"/>
          <c:y val="0.11122943790442"/>
          <c:w val="0.54103105036398802"/>
          <c:h val="0.66249421792573004"/>
        </c:manualLayout>
      </c:layout>
      <c:scatterChart>
        <c:scatterStyle val="lineMarker"/>
        <c:varyColors val="0"/>
        <c:ser>
          <c:idx val="1"/>
          <c:order val="0"/>
          <c:tx>
            <c:v>Strain W</c:v>
          </c:tx>
          <c:spPr>
            <a:ln w="28575">
              <a:solidFill>
                <a:sysClr val="windowText" lastClr="000000"/>
              </a:solidFill>
            </a:ln>
          </c:spPr>
          <c:marker>
            <c:symbol val="circle"/>
            <c:size val="7"/>
            <c:spPr>
              <a:solidFill>
                <a:sysClr val="window" lastClr="FFFFFF"/>
              </a:solidFill>
              <a:ln w="19050"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17030815.DT2 (3)'!$S$7:$S$31</c:f>
                <c:numCache>
                  <c:formatCode>General</c:formatCode>
                  <c:ptCount val="25"/>
                  <c:pt idx="0">
                    <c:v>0</c:v>
                  </c:pt>
                  <c:pt idx="1">
                    <c:v>2.1858128414339998E-3</c:v>
                  </c:pt>
                  <c:pt idx="2">
                    <c:v>8.1445278152470907E-3</c:v>
                  </c:pt>
                  <c:pt idx="3">
                    <c:v>1.1930353445448899E-2</c:v>
                  </c:pt>
                  <c:pt idx="4">
                    <c:v>1.9502136635080099E-2</c:v>
                  </c:pt>
                  <c:pt idx="5">
                    <c:v>1.53441990486452E-2</c:v>
                  </c:pt>
                  <c:pt idx="6">
                    <c:v>1.85831464863551E-2</c:v>
                  </c:pt>
                  <c:pt idx="7">
                    <c:v>1.52461288347057E-2</c:v>
                  </c:pt>
                  <c:pt idx="8">
                    <c:v>1.41931125706958E-2</c:v>
                  </c:pt>
                  <c:pt idx="9">
                    <c:v>1.9969421067666901E-2</c:v>
                  </c:pt>
                  <c:pt idx="10">
                    <c:v>2.1309882944566101E-2</c:v>
                  </c:pt>
                  <c:pt idx="11">
                    <c:v>1.2013880860626699E-2</c:v>
                  </c:pt>
                  <c:pt idx="12">
                    <c:v>2.3180451534284899E-2</c:v>
                  </c:pt>
                  <c:pt idx="13">
                    <c:v>3.1750765520080299E-2</c:v>
                  </c:pt>
                  <c:pt idx="14">
                    <c:v>3.1643851430149202E-2</c:v>
                  </c:pt>
                  <c:pt idx="15">
                    <c:v>5.14274029849629E-2</c:v>
                  </c:pt>
                  <c:pt idx="16">
                    <c:v>3.46041102247183E-2</c:v>
                  </c:pt>
                  <c:pt idx="17">
                    <c:v>3.12143129562917E-2</c:v>
                  </c:pt>
                  <c:pt idx="18">
                    <c:v>2.66729159344164E-2</c:v>
                  </c:pt>
                  <c:pt idx="19">
                    <c:v>3.7551446192006101E-2</c:v>
                  </c:pt>
                  <c:pt idx="20">
                    <c:v>4.5608235123835897E-2</c:v>
                  </c:pt>
                  <c:pt idx="21">
                    <c:v>3.97925174429117E-2</c:v>
                  </c:pt>
                  <c:pt idx="22">
                    <c:v>3.2186953878862001E-2</c:v>
                  </c:pt>
                  <c:pt idx="23">
                    <c:v>4.4545856522614398E-2</c:v>
                  </c:pt>
                  <c:pt idx="24">
                    <c:v>3.6555893277737297E-2</c:v>
                  </c:pt>
                </c:numCache>
              </c:numRef>
            </c:plus>
            <c:minus>
              <c:numRef>
                <c:f>'17030815.DT2 (3)'!$S$7:$S$31</c:f>
                <c:numCache>
                  <c:formatCode>General</c:formatCode>
                  <c:ptCount val="25"/>
                  <c:pt idx="0">
                    <c:v>0</c:v>
                  </c:pt>
                  <c:pt idx="1">
                    <c:v>2.1858128414339998E-3</c:v>
                  </c:pt>
                  <c:pt idx="2">
                    <c:v>8.1445278152470907E-3</c:v>
                  </c:pt>
                  <c:pt idx="3">
                    <c:v>1.1930353445448899E-2</c:v>
                  </c:pt>
                  <c:pt idx="4">
                    <c:v>1.9502136635080099E-2</c:v>
                  </c:pt>
                  <c:pt idx="5">
                    <c:v>1.53441990486452E-2</c:v>
                  </c:pt>
                  <c:pt idx="6">
                    <c:v>1.85831464863551E-2</c:v>
                  </c:pt>
                  <c:pt idx="7">
                    <c:v>1.52461288347057E-2</c:v>
                  </c:pt>
                  <c:pt idx="8">
                    <c:v>1.41931125706958E-2</c:v>
                  </c:pt>
                  <c:pt idx="9">
                    <c:v>1.9969421067666901E-2</c:v>
                  </c:pt>
                  <c:pt idx="10">
                    <c:v>2.1309882944566101E-2</c:v>
                  </c:pt>
                  <c:pt idx="11">
                    <c:v>1.2013880860626699E-2</c:v>
                  </c:pt>
                  <c:pt idx="12">
                    <c:v>2.3180451534284899E-2</c:v>
                  </c:pt>
                  <c:pt idx="13">
                    <c:v>3.1750765520080299E-2</c:v>
                  </c:pt>
                  <c:pt idx="14">
                    <c:v>3.1643851430149202E-2</c:v>
                  </c:pt>
                  <c:pt idx="15">
                    <c:v>5.14274029849629E-2</c:v>
                  </c:pt>
                  <c:pt idx="16">
                    <c:v>3.46041102247183E-2</c:v>
                  </c:pt>
                  <c:pt idx="17">
                    <c:v>3.12143129562917E-2</c:v>
                  </c:pt>
                  <c:pt idx="18">
                    <c:v>2.66729159344164E-2</c:v>
                  </c:pt>
                  <c:pt idx="19">
                    <c:v>3.7551446192006101E-2</c:v>
                  </c:pt>
                  <c:pt idx="20">
                    <c:v>4.5608235123835897E-2</c:v>
                  </c:pt>
                  <c:pt idx="21">
                    <c:v>3.97925174429117E-2</c:v>
                  </c:pt>
                  <c:pt idx="22">
                    <c:v>3.2186953878862001E-2</c:v>
                  </c:pt>
                  <c:pt idx="23">
                    <c:v>4.4545856522614398E-2</c:v>
                  </c:pt>
                  <c:pt idx="24">
                    <c:v>3.6555893277737297E-2</c:v>
                  </c:pt>
                </c:numCache>
              </c:numRef>
            </c:minus>
            <c:spPr>
              <a:ln w="19050"/>
            </c:spPr>
          </c:errBars>
          <c:xVal>
            <c:numRef>
              <c:f>'17030815.DT2 (3)'!$M$7:$M$31</c:f>
              <c:numCache>
                <c:formatCode>General</c:formatCode>
                <c:ptCount val="2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</c:numCache>
            </c:numRef>
          </c:xVal>
          <c:yVal>
            <c:numRef>
              <c:f>'17030815.DT2 (3)'!$T$7:$T$31</c:f>
              <c:numCache>
                <c:formatCode>General</c:formatCode>
                <c:ptCount val="25"/>
                <c:pt idx="0">
                  <c:v>0</c:v>
                </c:pt>
                <c:pt idx="1">
                  <c:v>-3.6666666666666701E-3</c:v>
                </c:pt>
                <c:pt idx="2">
                  <c:v>3.6999999999999998E-2</c:v>
                </c:pt>
                <c:pt idx="3">
                  <c:v>0.10199999999999999</c:v>
                </c:pt>
                <c:pt idx="4">
                  <c:v>0.19</c:v>
                </c:pt>
                <c:pt idx="5">
                  <c:v>0.36933333333333301</c:v>
                </c:pt>
                <c:pt idx="6">
                  <c:v>0.41299999999999998</c:v>
                </c:pt>
                <c:pt idx="7">
                  <c:v>0.41766666666666702</c:v>
                </c:pt>
                <c:pt idx="8">
                  <c:v>0.45266666666666699</c:v>
                </c:pt>
                <c:pt idx="9">
                  <c:v>0.44566666666666699</c:v>
                </c:pt>
                <c:pt idx="10">
                  <c:v>0.45533333333333298</c:v>
                </c:pt>
                <c:pt idx="11">
                  <c:v>0.44400000000000001</c:v>
                </c:pt>
                <c:pt idx="12">
                  <c:v>0.45700000000000002</c:v>
                </c:pt>
                <c:pt idx="13">
                  <c:v>0.44066666666666698</c:v>
                </c:pt>
                <c:pt idx="14">
                  <c:v>0.42499999999999999</c:v>
                </c:pt>
                <c:pt idx="15">
                  <c:v>0.44733333333333303</c:v>
                </c:pt>
                <c:pt idx="16">
                  <c:v>0.42733333333333301</c:v>
                </c:pt>
                <c:pt idx="17">
                  <c:v>0.432</c:v>
                </c:pt>
                <c:pt idx="18">
                  <c:v>0.41366666666666702</c:v>
                </c:pt>
                <c:pt idx="19">
                  <c:v>0.41966666666666702</c:v>
                </c:pt>
                <c:pt idx="20">
                  <c:v>0.41766666666666702</c:v>
                </c:pt>
                <c:pt idx="21">
                  <c:v>0.41466666666666702</c:v>
                </c:pt>
                <c:pt idx="22">
                  <c:v>0.40300000000000002</c:v>
                </c:pt>
                <c:pt idx="23">
                  <c:v>0.434</c:v>
                </c:pt>
                <c:pt idx="24">
                  <c:v>0.40799999999999997</c:v>
                </c:pt>
              </c:numCache>
            </c:numRef>
          </c:yVal>
          <c:smooth val="0"/>
        </c:ser>
        <c:ser>
          <c:idx val="0"/>
          <c:order val="1"/>
          <c:tx>
            <c:v>Strain F</c:v>
          </c:tx>
          <c:spPr>
            <a:ln w="28575">
              <a:solidFill>
                <a:sysClr val="windowText" lastClr="000000"/>
              </a:solidFill>
            </a:ln>
          </c:spPr>
          <c:marker>
            <c:symbol val="circle"/>
            <c:size val="7"/>
            <c:spPr>
              <a:solidFill>
                <a:sysClr val="windowText" lastClr="000000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17030815.DT2 (3)'!$J$7:$J$31</c:f>
                <c:numCache>
                  <c:formatCode>General</c:formatCode>
                  <c:ptCount val="25"/>
                  <c:pt idx="0">
                    <c:v>0</c:v>
                  </c:pt>
                  <c:pt idx="1">
                    <c:v>3.2829526005987001E-3</c:v>
                  </c:pt>
                  <c:pt idx="2">
                    <c:v>4.3333333333333297E-3</c:v>
                  </c:pt>
                  <c:pt idx="3">
                    <c:v>5.2387445485005697E-3</c:v>
                  </c:pt>
                  <c:pt idx="4">
                    <c:v>5.8118652580542302E-3</c:v>
                  </c:pt>
                  <c:pt idx="5">
                    <c:v>9.8375697089158002E-3</c:v>
                  </c:pt>
                  <c:pt idx="6">
                    <c:v>5.7831171909658299E-3</c:v>
                  </c:pt>
                  <c:pt idx="7">
                    <c:v>8.1921371516296693E-3</c:v>
                  </c:pt>
                  <c:pt idx="8">
                    <c:v>5.6075346137535696E-3</c:v>
                  </c:pt>
                  <c:pt idx="9">
                    <c:v>5.8118652580542302E-3</c:v>
                  </c:pt>
                  <c:pt idx="10">
                    <c:v>1.0837178804672601E-2</c:v>
                  </c:pt>
                  <c:pt idx="11">
                    <c:v>9.8206132417708106E-3</c:v>
                  </c:pt>
                  <c:pt idx="12">
                    <c:v>9.4926872439320999E-3</c:v>
                  </c:pt>
                  <c:pt idx="13">
                    <c:v>9.5277372853043007E-3</c:v>
                  </c:pt>
                  <c:pt idx="14">
                    <c:v>9.3867518935524894E-3</c:v>
                  </c:pt>
                  <c:pt idx="15">
                    <c:v>7.8810602783579292E-3</c:v>
                  </c:pt>
                  <c:pt idx="16">
                    <c:v>5.8401864506005097E-2</c:v>
                  </c:pt>
                  <c:pt idx="17">
                    <c:v>5.6772450282783403E-2</c:v>
                  </c:pt>
                  <c:pt idx="18">
                    <c:v>5.1286775423429902E-2</c:v>
                  </c:pt>
                  <c:pt idx="19">
                    <c:v>3.4961884007206102E-2</c:v>
                  </c:pt>
                  <c:pt idx="20">
                    <c:v>4.0513372277969299E-2</c:v>
                  </c:pt>
                  <c:pt idx="21">
                    <c:v>3.2338487561693101E-2</c:v>
                  </c:pt>
                  <c:pt idx="22">
                    <c:v>2.57358375292768E-2</c:v>
                  </c:pt>
                  <c:pt idx="23">
                    <c:v>2.7428695436227599E-2</c:v>
                  </c:pt>
                  <c:pt idx="24">
                    <c:v>2.7073972741361901E-2</c:v>
                  </c:pt>
                </c:numCache>
              </c:numRef>
            </c:plus>
            <c:minus>
              <c:numRef>
                <c:f>'17030815.DT2 (3)'!$J$7:$J$31</c:f>
                <c:numCache>
                  <c:formatCode>General</c:formatCode>
                  <c:ptCount val="25"/>
                  <c:pt idx="0">
                    <c:v>0</c:v>
                  </c:pt>
                  <c:pt idx="1">
                    <c:v>3.2829526005987001E-3</c:v>
                  </c:pt>
                  <c:pt idx="2">
                    <c:v>4.3333333333333297E-3</c:v>
                  </c:pt>
                  <c:pt idx="3">
                    <c:v>5.2387445485005697E-3</c:v>
                  </c:pt>
                  <c:pt idx="4">
                    <c:v>5.8118652580542302E-3</c:v>
                  </c:pt>
                  <c:pt idx="5">
                    <c:v>9.8375697089158002E-3</c:v>
                  </c:pt>
                  <c:pt idx="6">
                    <c:v>5.7831171909658299E-3</c:v>
                  </c:pt>
                  <c:pt idx="7">
                    <c:v>8.1921371516296693E-3</c:v>
                  </c:pt>
                  <c:pt idx="8">
                    <c:v>5.6075346137535696E-3</c:v>
                  </c:pt>
                  <c:pt idx="9">
                    <c:v>5.8118652580542302E-3</c:v>
                  </c:pt>
                  <c:pt idx="10">
                    <c:v>1.0837178804672601E-2</c:v>
                  </c:pt>
                  <c:pt idx="11">
                    <c:v>9.8206132417708106E-3</c:v>
                  </c:pt>
                  <c:pt idx="12">
                    <c:v>9.4926872439320999E-3</c:v>
                  </c:pt>
                  <c:pt idx="13">
                    <c:v>9.5277372853043007E-3</c:v>
                  </c:pt>
                  <c:pt idx="14">
                    <c:v>9.3867518935524894E-3</c:v>
                  </c:pt>
                  <c:pt idx="15">
                    <c:v>7.8810602783579292E-3</c:v>
                  </c:pt>
                  <c:pt idx="16">
                    <c:v>5.8401864506005097E-2</c:v>
                  </c:pt>
                  <c:pt idx="17">
                    <c:v>5.6772450282783403E-2</c:v>
                  </c:pt>
                  <c:pt idx="18">
                    <c:v>5.1286775423429902E-2</c:v>
                  </c:pt>
                  <c:pt idx="19">
                    <c:v>3.4961884007206102E-2</c:v>
                  </c:pt>
                  <c:pt idx="20">
                    <c:v>4.0513372277969299E-2</c:v>
                  </c:pt>
                  <c:pt idx="21">
                    <c:v>3.2338487561693101E-2</c:v>
                  </c:pt>
                  <c:pt idx="22">
                    <c:v>2.57358375292768E-2</c:v>
                  </c:pt>
                  <c:pt idx="23">
                    <c:v>2.7428695436227599E-2</c:v>
                  </c:pt>
                  <c:pt idx="24">
                    <c:v>2.7073972741361901E-2</c:v>
                  </c:pt>
                </c:numCache>
              </c:numRef>
            </c:minus>
            <c:spPr>
              <a:ln w="19050"/>
            </c:spPr>
          </c:errBars>
          <c:xVal>
            <c:numRef>
              <c:f>'17030815.DT2 (3)'!$D$7:$D$31</c:f>
              <c:numCache>
                <c:formatCode>General</c:formatCode>
                <c:ptCount val="2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</c:numCache>
            </c:numRef>
          </c:xVal>
          <c:yVal>
            <c:numRef>
              <c:f>'17030815.DT2 (3)'!$K$7:$K$31</c:f>
              <c:numCache>
                <c:formatCode>General</c:formatCode>
                <c:ptCount val="2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.33333333333333E-3</c:v>
                </c:pt>
                <c:pt idx="6">
                  <c:v>6.6666666666666697E-4</c:v>
                </c:pt>
                <c:pt idx="7">
                  <c:v>3.3333333333333301E-3</c:v>
                </c:pt>
                <c:pt idx="8">
                  <c:v>1.1333333333333299E-2</c:v>
                </c:pt>
                <c:pt idx="9">
                  <c:v>1.36666666666667E-2</c:v>
                </c:pt>
                <c:pt idx="10">
                  <c:v>2.1666666666666699E-2</c:v>
                </c:pt>
                <c:pt idx="11">
                  <c:v>2.4333333333333301E-2</c:v>
                </c:pt>
                <c:pt idx="12">
                  <c:v>3.3666666666666699E-2</c:v>
                </c:pt>
                <c:pt idx="13">
                  <c:v>4.0333333333333297E-2</c:v>
                </c:pt>
                <c:pt idx="14">
                  <c:v>4.9333333333333299E-2</c:v>
                </c:pt>
                <c:pt idx="15">
                  <c:v>5.3333333333333302E-2</c:v>
                </c:pt>
                <c:pt idx="16">
                  <c:v>0.117666666666667</c:v>
                </c:pt>
                <c:pt idx="17">
                  <c:v>0.15666666666666701</c:v>
                </c:pt>
                <c:pt idx="18">
                  <c:v>0.13300000000000001</c:v>
                </c:pt>
                <c:pt idx="19">
                  <c:v>0.157</c:v>
                </c:pt>
                <c:pt idx="20">
                  <c:v>0.16900000000000001</c:v>
                </c:pt>
                <c:pt idx="21">
                  <c:v>0.16766666666666699</c:v>
                </c:pt>
                <c:pt idx="22">
                  <c:v>0.16500000000000001</c:v>
                </c:pt>
                <c:pt idx="23">
                  <c:v>0.16400000000000001</c:v>
                </c:pt>
                <c:pt idx="24">
                  <c:v>0.1789999999999999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2234624"/>
        <c:axId val="132236800"/>
      </c:scatterChart>
      <c:valAx>
        <c:axId val="132234624"/>
        <c:scaling>
          <c:orientation val="minMax"/>
          <c:max val="26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lang="ja-JP" sz="2000"/>
                </a:pPr>
                <a:r>
                  <a:rPr lang="en-US" sz="2000"/>
                  <a:t>Time (h)</a:t>
                </a:r>
                <a:endParaRPr lang="ja-JP" sz="2000"/>
              </a:p>
            </c:rich>
          </c:tx>
          <c:layout>
            <c:manualLayout>
              <c:xMode val="edge"/>
              <c:yMode val="edge"/>
              <c:x val="0.39241871495622799"/>
              <c:y val="0.88273927392739304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25400">
            <a:solidFill>
              <a:sysClr val="windowText" lastClr="000000"/>
            </a:solidFill>
          </a:ln>
        </c:spPr>
        <c:txPr>
          <a:bodyPr rot="0" vert="horz"/>
          <a:lstStyle/>
          <a:p>
            <a:pPr>
              <a:defRPr lang="ja-JP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132236800"/>
        <c:crosses val="autoZero"/>
        <c:crossBetween val="midCat"/>
        <c:majorUnit val="6"/>
      </c:valAx>
      <c:valAx>
        <c:axId val="132236800"/>
        <c:scaling>
          <c:orientation val="minMax"/>
          <c:max val="0.6"/>
          <c:min val="0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/>
              <a:lstStyle/>
              <a:p>
                <a:pPr>
                  <a:defRPr lang="ja-JP" sz="20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2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OD</a:t>
                </a:r>
                <a:r>
                  <a:rPr lang="en-US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660</a:t>
                </a:r>
                <a:endParaRPr lang="ja-JP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2.2683328105999299E-2"/>
              <c:y val="0.3442337777084800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25400">
            <a:solidFill>
              <a:sysClr val="windowText" lastClr="000000"/>
            </a:solidFill>
          </a:ln>
        </c:spPr>
        <c:txPr>
          <a:bodyPr/>
          <a:lstStyle/>
          <a:p>
            <a:pPr>
              <a:defRPr lang="ja-JP" b="1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defRPr>
            </a:pPr>
            <a:endParaRPr lang="ja-JP"/>
          </a:p>
        </c:txPr>
        <c:crossAx val="132234624"/>
        <c:crosses val="autoZero"/>
        <c:crossBetween val="midCat"/>
        <c:majorUnit val="0.1"/>
      </c:valAx>
      <c:spPr>
        <a:ln w="25400">
          <a:solidFill>
            <a:sysClr val="windowText" lastClr="000000"/>
          </a:solidFill>
        </a:ln>
      </c:spPr>
    </c:plotArea>
    <c:legend>
      <c:legendPos val="r"/>
      <c:layout>
        <c:manualLayout>
          <c:xMode val="edge"/>
          <c:yMode val="edge"/>
          <c:x val="0.77639357973335099"/>
          <c:y val="0.110161638211065"/>
          <c:w val="0.20403968371878001"/>
          <c:h val="0.15183856968373999"/>
        </c:manualLayout>
      </c:layout>
      <c:overlay val="0"/>
      <c:spPr>
        <a:ln w="12700">
          <a:solidFill>
            <a:sysClr val="windowText" lastClr="000000"/>
          </a:solidFill>
        </a:ln>
      </c:spPr>
      <c:txPr>
        <a:bodyPr/>
        <a:lstStyle/>
        <a:p>
          <a:pPr>
            <a:defRPr lang="ja-JP" sz="1200" b="1" baseline="0">
              <a:latin typeface="Calibri" panose="020F0502020204030204" pitchFamily="34" charset="0"/>
              <a:ea typeface="Arial Unicode MS" panose="020B0604020202020204" pitchFamily="50" charset="-128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</c:chart>
  <c:spPr>
    <a:solidFill>
      <a:sysClr val="window" lastClr="FFFFFF"/>
    </a:solidFill>
    <a:ln>
      <a:noFill/>
    </a:ln>
  </c:spPr>
  <c:txPr>
    <a:bodyPr/>
    <a:lstStyle/>
    <a:p>
      <a:pPr>
        <a:defRPr sz="1600"/>
      </a:pPr>
      <a:endParaRPr lang="ja-JP"/>
    </a:p>
  </c:txPr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21000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19525" y="0"/>
            <a:ext cx="2921000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73E732D-E684-9E48-8EEC-E613AC00203E}" type="datetimeFigureOut">
              <a:rPr lang="en-US" smtClean="0"/>
              <a:t>6/20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9350" y="1233488"/>
            <a:ext cx="4443413" cy="33321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4688" y="4751388"/>
            <a:ext cx="5392737" cy="38877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7363"/>
            <a:ext cx="2921000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19525" y="9377363"/>
            <a:ext cx="2921000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01F5E69-8F82-9647-8F6E-1ED471233B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72139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01F5E69-8F82-9647-8F6E-1ED471233B4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71420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6BCCCB-9176-436E-A466-0131FC662DE8}" type="datetimeFigureOut">
              <a:rPr kumimoji="1" lang="ja-JP" altLang="en-US" smtClean="0"/>
              <a:t>2017/6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1B47E-6C48-446A-8DB4-9F83C6526F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18945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6BCCCB-9176-436E-A466-0131FC662DE8}" type="datetimeFigureOut">
              <a:rPr kumimoji="1" lang="ja-JP" altLang="en-US" smtClean="0"/>
              <a:t>2017/6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1B47E-6C48-446A-8DB4-9F83C6526F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30067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6BCCCB-9176-436E-A466-0131FC662DE8}" type="datetimeFigureOut">
              <a:rPr kumimoji="1" lang="ja-JP" altLang="en-US" smtClean="0"/>
              <a:t>2017/6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1B47E-6C48-446A-8DB4-9F83C6526F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10739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6BCCCB-9176-436E-A466-0131FC662DE8}" type="datetimeFigureOut">
              <a:rPr kumimoji="1" lang="ja-JP" altLang="en-US" smtClean="0"/>
              <a:t>2017/6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1B47E-6C48-446A-8DB4-9F83C6526F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85382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6BCCCB-9176-436E-A466-0131FC662DE8}" type="datetimeFigureOut">
              <a:rPr kumimoji="1" lang="ja-JP" altLang="en-US" smtClean="0"/>
              <a:t>2017/6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1B47E-6C48-446A-8DB4-9F83C6526F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68342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6BCCCB-9176-436E-A466-0131FC662DE8}" type="datetimeFigureOut">
              <a:rPr kumimoji="1" lang="ja-JP" altLang="en-US" smtClean="0"/>
              <a:t>2017/6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1B47E-6C48-446A-8DB4-9F83C6526F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10861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6BCCCB-9176-436E-A466-0131FC662DE8}" type="datetimeFigureOut">
              <a:rPr kumimoji="1" lang="ja-JP" altLang="en-US" smtClean="0"/>
              <a:t>2017/6/2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1B47E-6C48-446A-8DB4-9F83C6526F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50365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6BCCCB-9176-436E-A466-0131FC662DE8}" type="datetimeFigureOut">
              <a:rPr kumimoji="1" lang="ja-JP" altLang="en-US" smtClean="0"/>
              <a:t>2017/6/2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1B47E-6C48-446A-8DB4-9F83C6526F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56044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6BCCCB-9176-436E-A466-0131FC662DE8}" type="datetimeFigureOut">
              <a:rPr kumimoji="1" lang="ja-JP" altLang="en-US" smtClean="0"/>
              <a:t>2017/6/2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1B47E-6C48-446A-8DB4-9F83C6526F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69923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6BCCCB-9176-436E-A466-0131FC662DE8}" type="datetimeFigureOut">
              <a:rPr kumimoji="1" lang="ja-JP" altLang="en-US" smtClean="0"/>
              <a:t>2017/6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1B47E-6C48-446A-8DB4-9F83C6526F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7042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6BCCCB-9176-436E-A466-0131FC662DE8}" type="datetimeFigureOut">
              <a:rPr kumimoji="1" lang="ja-JP" altLang="en-US" smtClean="0"/>
              <a:t>2017/6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1B47E-6C48-446A-8DB4-9F83C6526F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12254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6BCCCB-9176-436E-A466-0131FC662DE8}" type="datetimeFigureOut">
              <a:rPr kumimoji="1" lang="ja-JP" altLang="en-US" smtClean="0"/>
              <a:t>2017/6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F1B47E-6C48-446A-8DB4-9F83C6526F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46746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/>
          <p:cNvSpPr/>
          <p:nvPr/>
        </p:nvSpPr>
        <p:spPr>
          <a:xfrm>
            <a:off x="539552" y="836712"/>
            <a:ext cx="8208912" cy="504753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terial</a:t>
            </a:r>
          </a:p>
          <a:p>
            <a:endParaRPr lang="ja-JP" altLang="ja-JP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B </a:t>
            </a:r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ress</a:t>
            </a:r>
          </a:p>
          <a:p>
            <a:endParaRPr lang="ja-JP" altLang="ja-JP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otransformation of </a:t>
            </a:r>
            <a:r>
              <a:rPr lang="en-US" altLang="ja-JP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erulic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id to </a:t>
            </a:r>
            <a:r>
              <a:rPr lang="en-US" altLang="ja-JP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ocatehuic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id by </a:t>
            </a:r>
            <a:r>
              <a:rPr lang="en-US" altLang="ja-JP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ynebacterium </a:t>
            </a:r>
            <a:r>
              <a:rPr lang="en-US" altLang="ja-JP" sz="14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utamicum</a:t>
            </a:r>
            <a:r>
              <a:rPr lang="en-US" altLang="ja-JP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CC21420 engineered to express </a:t>
            </a:r>
            <a:r>
              <a:rPr lang="en-US" altLang="ja-JP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nillate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demethylase</a:t>
            </a:r>
            <a:r>
              <a:rPr lang="en-US" altLang="ja-JP" sz="14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endParaRPr lang="ja-JP" altLang="ja-JP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s-E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aoko Okai</a:t>
            </a:r>
            <a:r>
              <a:rPr lang="es-ES" altLang="ja-JP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s-E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akaya Masuda</a:t>
            </a:r>
            <a:r>
              <a:rPr lang="es-ES" altLang="ja-JP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s-E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Yasunobu Takeshima</a:t>
            </a:r>
            <a:r>
              <a:rPr lang="es-ES" altLang="ja-JP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s-E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Kosei Tanaka</a:t>
            </a:r>
            <a:r>
              <a:rPr lang="es-ES" altLang="ja-JP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s-E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Ken-ichi Yoshida</a:t>
            </a:r>
            <a:r>
              <a:rPr lang="es-ES" altLang="ja-JP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s-E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asanori Miyamoto</a:t>
            </a:r>
            <a:r>
              <a:rPr lang="es-ES" altLang="ja-JP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s-E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hiaki Ogino</a:t>
            </a:r>
            <a:r>
              <a:rPr lang="es-ES" altLang="ja-JP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s-E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Akihiko </a:t>
            </a:r>
            <a:r>
              <a:rPr lang="es-E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ondo</a:t>
            </a:r>
            <a:r>
              <a:rPr lang="es-ES" altLang="ja-JP" sz="14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,5</a:t>
            </a:r>
            <a:r>
              <a:rPr lang="ja-JP" altLang="ja-JP" sz="14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＊</a:t>
            </a:r>
            <a:endParaRPr lang="ja-JP" altLang="ja-JP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s-E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endParaRPr lang="ja-JP" altLang="ja-JP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s-ES" altLang="ja-JP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s-E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aduate School of Science, Technology, and Innovation, Kobe University, 1-1 Rokkodaicho, Kobe 657-8501, Japan</a:t>
            </a:r>
            <a:endParaRPr lang="ja-JP" altLang="ja-JP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s-ES" altLang="ja-JP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s-E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aw Materials and Polymers Technology Department, Raw Materials and Polymers Division, Teijin Limited, 2345 Nishihabu-cho, Matsuyama-shi, Ehime, 791-8536, Japan </a:t>
            </a:r>
            <a:endParaRPr lang="ja-JP" altLang="ja-JP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s-ES" altLang="ja-JP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s-E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rganization of Advanced Science and Technology, Kobe University, 1-1 Rokkodaicho, Kobe 657-8501, Japan</a:t>
            </a:r>
            <a:endParaRPr lang="ja-JP" altLang="ja-JP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s-ES" altLang="ja-JP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s-E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epartment of Chemical Science and Engineering, Graduate School of Engineering, Kobe University, 1-1 Rokkodaicho, Kobe 657-8501, Japan</a:t>
            </a:r>
            <a:endParaRPr lang="ja-JP" altLang="ja-JP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s-ES" altLang="ja-JP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s-E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iomass Engineering Program, RIKEN, 1-7-22 Suehiro-cho, Tsurumi-ku, Yokohama 230-0045, </a:t>
            </a:r>
            <a:r>
              <a:rPr lang="es-E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apan</a:t>
            </a:r>
          </a:p>
          <a:p>
            <a:endParaRPr lang="ja-JP" altLang="ja-JP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s-E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 Corresponding author; Akihiko Kondo </a:t>
            </a:r>
            <a:endParaRPr lang="ja-JP" altLang="ja-JP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s-E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mail : akondo@kobe-u.ac.jp (A. Kondo)</a:t>
            </a:r>
            <a:endParaRPr lang="ja-JP" altLang="ja-JP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s-E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l: +81-78-803-6196; Fax: +81-78-803-6196 </a:t>
            </a:r>
            <a:endParaRPr lang="ja-JP" altLang="ja-JP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s-E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ja-JP" altLang="ja-JP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757736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グラフ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58139709"/>
              </p:ext>
            </p:extLst>
          </p:nvPr>
        </p:nvGraphicFramePr>
        <p:xfrm>
          <a:off x="2300287" y="1268760"/>
          <a:ext cx="4543425" cy="38481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テキスト ボックス 3"/>
          <p:cNvSpPr txBox="1"/>
          <p:nvPr/>
        </p:nvSpPr>
        <p:spPr>
          <a:xfrm>
            <a:off x="550105" y="5373216"/>
            <a:ext cx="8064896" cy="10464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Growth of </a:t>
            </a:r>
            <a:r>
              <a:rPr lang="en-US" altLang="ja-JP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ja-JP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utamicum</a:t>
            </a:r>
            <a:r>
              <a:rPr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ins F and W in BT-PCA medium.</a:t>
            </a:r>
          </a:p>
          <a:p>
            <a:pPr algn="just"/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glutamicum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ins F (closed symbols) and W (open symbols) were grown in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 mL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BHI medium for 24 h at 30</a:t>
            </a:r>
            <a:r>
              <a:rPr lang="en-US" altLang="ja-JP" sz="12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℃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Each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rter culture (0.1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L) was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oculated into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 mL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BT-2mM PCA medium. The two strains were cultured at 30</a:t>
            </a:r>
            <a:r>
              <a:rPr lang="en-US" altLang="ja-JP" sz="1200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℃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 agitation at 60 rpm for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4 h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optical densities at 660nm were monitored once hourly.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data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 the mean and standard error of three independent experiments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398198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53</TotalTime>
  <Words>157</Words>
  <Application>Microsoft Office PowerPoint</Application>
  <PresentationFormat>画面に合わせる (4:3)</PresentationFormat>
  <Paragraphs>24</Paragraphs>
  <Slides>2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3" baseType="lpstr">
      <vt:lpstr>Office ​​テーマ</vt:lpstr>
      <vt:lpstr>PowerPoint プレゼンテーション</vt:lpstr>
      <vt:lpstr>PowerPoint プレゼンテーション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aoko Okai</dc:creator>
  <cp:lastModifiedBy>Nao Miyano</cp:lastModifiedBy>
  <cp:revision>18</cp:revision>
  <cp:lastPrinted>2017-05-22T12:03:36Z</cp:lastPrinted>
  <dcterms:created xsi:type="dcterms:W3CDTF">2017-05-19T05:22:49Z</dcterms:created>
  <dcterms:modified xsi:type="dcterms:W3CDTF">2017-06-20T01:02:11Z</dcterms:modified>
</cp:coreProperties>
</file>